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74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59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</p:sldMasterIdLst>
  <p:notesMasterIdLst>
    <p:notesMasterId r:id="rId11"/>
  </p:notesMasterIdLst>
  <p:sldIdLst>
    <p:sldId id="256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notesMaster" Target="notesMasters/notesMaster1.xml"/><Relationship Id="rId12" Type="http://schemas.openxmlformats.org/officeDocument/2006/relationships/slide" Target="slides/slide1.xml"/><Relationship Id="rId1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10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9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0" name="PlaceHolder 2"/>
          <p:cNvSpPr>
            <a:spLocks noGrp="1"/>
          </p:cNvSpPr>
          <p:nvPr>
            <p:ph type="dt" idx="7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1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60ad"/>
                </a:solidFill>
                <a:latin typeface="Arial"/>
              </a:rPr>
              <a:t>Click to move the slide</a:t>
            </a: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52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5"/>
          <p:cNvSpPr>
            <a:spLocks noGrp="1"/>
          </p:cNvSpPr>
          <p:nvPr>
            <p:ph type="ftr" idx="8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4" name="PlaceHolder 6"/>
          <p:cNvSpPr>
            <a:spLocks noGrp="1"/>
          </p:cNvSpPr>
          <p:nvPr>
            <p:ph type="sldNum" idx="9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B6A7BC-6818-420C-ADAC-6657930B6CAA}" type="slidenum"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25E58F-1174-4F36-822D-CA30BD2BC0A3}" type="slidenum">
              <a:rPr b="1" lang="de-DE" sz="12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37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5EE8863-606E-4296-B7C6-5EEF7277D246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656751B-7474-4EAA-893F-B6AC4AEBA2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26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3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3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4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C91685C-641A-42C4-B726-BCF38ACFE9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02FADE6-B722-418C-8085-D1D576B70613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7C414-40A4-4AC7-B1DA-4BBEBEF2973E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77BE1-4C1E-4B6D-A96C-D63CFE5ED1EB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B2F37-D095-4692-AF02-D9000C1633C0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626F76-4A39-43E3-8FEC-B0C6238248F4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24BDD-BA2F-4040-99F3-659ABF5F4D50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BF5F3-52AE-4A5A-8345-F1C9367F45D2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B2BDA-F9ED-45D8-98F5-FC91FED6A017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EF9ADCE-4E54-429B-BD25-B54F8B7FC0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6F269-E957-48DD-A472-D445412BE395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65A95-9DF4-4A28-8CE3-874A1DA27CE6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7209E-65CA-4123-9B7A-0777290153B2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72670C-E46B-4046-B44C-D159D612B105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61F97-494B-41E7-9858-DE899817CA14}" type="slidenum">
              <a:t>&lt;#&gt;</a:t>
            </a:fld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E3C0E5CF-5DF0-4EE8-A367-BB02894B7EE8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E0AF5218-77AA-4EBE-8691-3A49715A94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E89811EA-C9E2-4AF0-8AE7-F1996495A0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8BE36988-28C9-4BB3-A308-37B3FBD3F4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DAB5930C-1E33-460D-8DD2-ED6EFB6EDC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12D1D08-5F68-4CC5-BE2F-8F48B5145B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9032B6C8-53A4-4AFD-A172-3267C8645F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3910FD2D-0A3A-4BF0-AE8C-89C8630C14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F5DB2A6E-3DE7-4B2F-B1BB-9B5A600B89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D152B7FE-43EC-4AF9-98AC-FA8EF20CC8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A08F4DED-7434-47AF-9F9F-425BB695F7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FE9C060C-99CC-4E62-B320-4AC6BD770E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9B5E31DC-1DC0-4035-AD61-517D7AD2FB34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26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C54F231-2F91-471B-BBAE-B0A720BEE3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4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57ABBCC-CBB1-438C-ABC9-47BACC0313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69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81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121D10A-8711-49AF-85D6-1E5D7FBD55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9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0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09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BD0081B-8D9D-47EA-B635-C0C57B2B42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1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2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36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41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6176ED0-7D6C-4473-9107-1AE1B4D6A4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4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49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5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22757C0-7488-417F-94E5-9DA70ADF158B}" type="slidenum">
              <a:t>&lt;#&gt;</a:t>
            </a:fld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71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36EE6B0-B0A1-44F8-894C-568CAC1B56AF}" type="slidenum">
              <a:t>&lt;#&gt;</a:t>
            </a:fld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B6A0B30-4451-42EF-865E-6A9C46B8730F}" type="slidenum">
              <a:t>&lt;#&gt;</a:t>
            </a:fld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7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08167F-8D9A-44A1-A845-947B5EA9CE99}" type="slidenum">
              <a:t>&lt;#&gt;</a:t>
            </a:fld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F785AC7-A773-4037-B7DC-50A7007DEDF8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D94DC8A-F3A2-4079-BA37-A9E296736F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C89E9A3-035E-4E52-B3D7-084BACD60BB1}" type="slidenum">
              <a:t>&lt;#&gt;</a:t>
            </a:fld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F102538-FDB3-43DF-A24B-BC36D2571966}" type="slidenum">
              <a:t>&lt;#&gt;</a:t>
            </a:fld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84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5A2B470-9CED-4345-B0E3-ADBEA5FA52FD}" type="slidenum">
              <a:t>&lt;#&gt;</a:t>
            </a:fld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DFABF6A-B7CB-4AF9-BEDB-9F4BDA16EB32}" type="slidenum">
              <a:t>&lt;#&gt;</a:t>
            </a:fld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9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94D1244-C4E8-4854-91E4-6CD8CFCF511B}" type="slidenum">
              <a:t>&lt;#&gt;</a:t>
            </a:fld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CA7F13A-1B45-4824-BE90-BF28CDF755B6}" type="slidenum">
              <a:t>&lt;#&gt;</a:t>
            </a:fld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0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CE3346E-6674-487F-9755-003249F6A2CF}" type="slidenum">
              <a:t>&lt;#&gt;</a:t>
            </a:fld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13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1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97.xml"/><Relationship Id="rId5" Type="http://schemas.openxmlformats.org/officeDocument/2006/relationships/slideLayout" Target="../slideLayouts/slideLayout98.xml"/><Relationship Id="rId6" Type="http://schemas.openxmlformats.org/officeDocument/2006/relationships/slideLayout" Target="../slideLayouts/slideLayout99.xml"/><Relationship Id="rId7" Type="http://schemas.openxmlformats.org/officeDocument/2006/relationships/slideLayout" Target="../slideLayouts/slideLayout100.xml"/><Relationship Id="rId8" Type="http://schemas.openxmlformats.org/officeDocument/2006/relationships/slideLayout" Target="../slideLayouts/slideLayout101.xml"/><Relationship Id="rId9" Type="http://schemas.openxmlformats.org/officeDocument/2006/relationships/slideLayout" Target="../slideLayouts/slideLayout102.xml"/><Relationship Id="rId10" Type="http://schemas.openxmlformats.org/officeDocument/2006/relationships/slideLayout" Target="../slideLayouts/slideLayout103.xml"/><Relationship Id="rId11" Type="http://schemas.openxmlformats.org/officeDocument/2006/relationships/slideLayout" Target="../slideLayouts/slideLayout104.xml"/><Relationship Id="rId12" Type="http://schemas.openxmlformats.org/officeDocument/2006/relationships/slideLayout" Target="../slideLayouts/slideLayout105.xml"/><Relationship Id="rId13" Type="http://schemas.openxmlformats.org/officeDocument/2006/relationships/slideLayout" Target="../slideLayouts/slideLayout106.xml"/><Relationship Id="rId14" Type="http://schemas.openxmlformats.org/officeDocument/2006/relationships/slideLayout" Target="../slideLayouts/slideLayout107.xml"/><Relationship Id="rId15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90138"/>
            </a:gs>
            <a:gs pos="100000">
              <a:srgbClr val="130278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8640" y="204480"/>
            <a:ext cx="8382240" cy="942840"/>
          </a:xfrm>
          <a:prstGeom prst="rect">
            <a:avLst/>
          </a:prstGeom>
          <a:noFill/>
          <a:ln w="0">
            <a:noFill/>
          </a:ln>
        </p:spPr>
        <p:txBody>
          <a:bodyPr lIns="0" rIns="0" tIns="46080" bIns="4608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ffff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8640" y="1333080"/>
            <a:ext cx="8382240" cy="4838760"/>
          </a:xfrm>
          <a:prstGeom prst="rect">
            <a:avLst/>
          </a:prstGeom>
          <a:noFill/>
          <a:ln w="0">
            <a:noFill/>
          </a:ln>
        </p:spPr>
        <p:txBody>
          <a:bodyPr lIns="0" rIns="0" tIns="46080" bIns="46080" anchor="t">
            <a:normAutofit/>
          </a:bodyPr>
          <a:p>
            <a:pPr marL="341280" indent="-34128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1240" indent="-28404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084320" indent="-22716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3" marL="1427040" indent="-22680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4" marL="1770120" indent="-22716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5" marL="1770120" indent="-227160">
              <a:lnSpc>
                <a:spcPct val="95000"/>
              </a:lnSpc>
              <a:spcBef>
                <a:spcPts val="1950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6" marL="1770120" indent="-227160">
              <a:lnSpc>
                <a:spcPct val="95000"/>
              </a:lnSpc>
              <a:spcBef>
                <a:spcPts val="1950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55320" y="-360"/>
            <a:ext cx="3284280" cy="152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Text Box 5"/>
          <p:cNvSpPr/>
          <p:nvPr/>
        </p:nvSpPr>
        <p:spPr>
          <a:xfrm>
            <a:off x="76320" y="6570720"/>
            <a:ext cx="183960" cy="23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Rectangle 6"/>
          <p:cNvSpPr/>
          <p:nvPr/>
        </p:nvSpPr>
        <p:spPr>
          <a:xfrm>
            <a:off x="0" y="1170000"/>
            <a:ext cx="9144000" cy="369720"/>
          </a:xfrm>
          <a:prstGeom prst="rect">
            <a:avLst/>
          </a:prstGeom>
          <a:gradFill rotWithShape="0">
            <a:gsLst>
              <a:gs pos="0">
                <a:srgbClr val="99ccff"/>
              </a:gs>
              <a:gs pos="100000">
                <a:srgbClr val="273441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>
          <a:xfrm>
            <a:off x="7009920" y="6568560"/>
            <a:ext cx="2133720" cy="289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925811-CC13-49E7-92DD-0570C0626C96}" type="slidenum">
              <a:rPr b="0" lang="en-GB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00"/>
            </a:gs>
            <a:gs pos="100000">
              <a:srgbClr val="000099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92040" y="76320"/>
            <a:ext cx="8359920" cy="109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ffff00"/>
                </a:solidFill>
                <a:latin typeface="Arial"/>
              </a:rPr>
              <a:t>Click to edit the title text format</a:t>
            </a:r>
            <a:endParaRPr b="1" lang="en-US" sz="3200" spc="-1" strike="noStrike">
              <a:solidFill>
                <a:srgbClr val="ffff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391680" y="1568160"/>
            <a:ext cx="8427960" cy="486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31840" indent="-231840">
              <a:spcBef>
                <a:spcPts val="601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689040" indent="-341280">
              <a:spcBef>
                <a:spcPts val="601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085760" indent="-280800">
              <a:spcBef>
                <a:spcPts val="601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3" marL="1542960" indent="-341280">
              <a:spcBef>
                <a:spcPts val="601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4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5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6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Num" idx="3"/>
          </p:nvPr>
        </p:nvSpPr>
        <p:spPr>
          <a:xfrm>
            <a:off x="6857640" y="64321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F28A55-418F-437B-9B54-8E7A1C2AC1BA}" type="slidenum"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90138"/>
            </a:gs>
            <a:gs pos="100000">
              <a:srgbClr val="130278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458640" y="204480"/>
            <a:ext cx="8382240" cy="942840"/>
          </a:xfrm>
          <a:prstGeom prst="rect">
            <a:avLst/>
          </a:prstGeom>
          <a:noFill/>
          <a:ln w="0">
            <a:noFill/>
          </a:ln>
        </p:spPr>
        <p:txBody>
          <a:bodyPr lIns="0" rIns="0" tIns="46080" bIns="4608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ffff00"/>
              </a:solidFill>
              <a:latin typeface="Arial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458640" y="1333080"/>
            <a:ext cx="8382240" cy="4838760"/>
          </a:xfrm>
          <a:prstGeom prst="rect">
            <a:avLst/>
          </a:prstGeom>
          <a:noFill/>
          <a:ln w="0">
            <a:noFill/>
          </a:ln>
        </p:spPr>
        <p:txBody>
          <a:bodyPr lIns="0" rIns="0" tIns="46080" bIns="46080" anchor="t">
            <a:normAutofit/>
          </a:bodyPr>
          <a:p>
            <a:pPr marL="341280" indent="-34128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1240" indent="-28404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084320" indent="-22716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3" marL="1427040" indent="-22680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4" marL="1770120" indent="-22716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5" marL="1770120" indent="-227160">
              <a:lnSpc>
                <a:spcPct val="95000"/>
              </a:lnSpc>
              <a:spcBef>
                <a:spcPts val="1950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6" marL="1770120" indent="-227160">
              <a:lnSpc>
                <a:spcPct val="95000"/>
              </a:lnSpc>
              <a:spcBef>
                <a:spcPts val="1950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 type="dt" idx="4"/>
          </p:nvPr>
        </p:nvSpPr>
        <p:spPr>
          <a:xfrm>
            <a:off x="355320" y="-360"/>
            <a:ext cx="3284280" cy="152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Text Box 5"/>
          <p:cNvSpPr/>
          <p:nvPr/>
        </p:nvSpPr>
        <p:spPr>
          <a:xfrm>
            <a:off x="76320" y="6570720"/>
            <a:ext cx="183960" cy="23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Rectangle 6"/>
          <p:cNvSpPr/>
          <p:nvPr/>
        </p:nvSpPr>
        <p:spPr>
          <a:xfrm>
            <a:off x="0" y="1170000"/>
            <a:ext cx="9144000" cy="369720"/>
          </a:xfrm>
          <a:prstGeom prst="rect">
            <a:avLst/>
          </a:prstGeom>
          <a:gradFill rotWithShape="0">
            <a:gsLst>
              <a:gs pos="0">
                <a:srgbClr val="99ccff"/>
              </a:gs>
              <a:gs pos="100000">
                <a:srgbClr val="273441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sldNum" idx="5"/>
          </p:nvPr>
        </p:nvSpPr>
        <p:spPr>
          <a:xfrm>
            <a:off x="7009920" y="6568560"/>
            <a:ext cx="2133720" cy="289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1F9FFA-E1C1-44F3-8527-A8BFE4D3E929}" type="slidenum">
              <a:rPr b="0" lang="en-GB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00"/>
            </a:gs>
            <a:gs pos="100000">
              <a:srgbClr val="000099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392040" y="76320"/>
            <a:ext cx="8359920" cy="109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ffff00"/>
                </a:solidFill>
                <a:latin typeface="Arial"/>
              </a:rPr>
              <a:t>Click to edit the title text format</a:t>
            </a:r>
            <a:endParaRPr b="1" lang="en-US" sz="3200" spc="-1" strike="noStrike">
              <a:solidFill>
                <a:srgbClr val="ffff00"/>
              </a:solidFill>
              <a:latin typeface="Arial"/>
            </a:endParaRPr>
          </a:p>
        </p:txBody>
      </p:sp>
      <p:sp>
        <p:nvSpPr>
          <p:cNvPr id="268" name="PlaceHolder 2"/>
          <p:cNvSpPr>
            <a:spLocks noGrp="1"/>
          </p:cNvSpPr>
          <p:nvPr>
            <p:ph type="body"/>
          </p:nvPr>
        </p:nvSpPr>
        <p:spPr>
          <a:xfrm>
            <a:off x="391680" y="1568160"/>
            <a:ext cx="8427960" cy="486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31840" indent="-231840">
              <a:spcBef>
                <a:spcPts val="601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689040" indent="-341280">
              <a:spcBef>
                <a:spcPts val="601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085760" indent="-280800">
              <a:spcBef>
                <a:spcPts val="601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3" marL="1542960" indent="-341280">
              <a:spcBef>
                <a:spcPts val="601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4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5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6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9" name="PlaceHolder 3"/>
          <p:cNvSpPr>
            <a:spLocks noGrp="1"/>
          </p:cNvSpPr>
          <p:nvPr>
            <p:ph type="sldNum" idx="6"/>
          </p:nvPr>
        </p:nvSpPr>
        <p:spPr>
          <a:xfrm>
            <a:off x="7086240" y="64321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595ED9-2E32-4771-9E11-75EB06346789}" type="slidenum">
              <a:rPr b="0" lang="en-US" sz="10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6" name="Imagen 1" descr="Portada4.jpg"/>
          <p:cNvPicPr/>
          <p:nvPr/>
        </p:nvPicPr>
        <p:blipFill>
          <a:blip r:embed="rId2"/>
          <a:stretch/>
        </p:blipFill>
        <p:spPr>
          <a:xfrm>
            <a:off x="0" y="0"/>
            <a:ext cx="9139320" cy="6858000"/>
          </a:xfrm>
          <a:prstGeom prst="rect">
            <a:avLst/>
          </a:prstGeom>
          <a:ln w="0">
            <a:noFill/>
          </a:ln>
        </p:spPr>
      </p:pic>
      <p:pic>
        <p:nvPicPr>
          <p:cNvPr id="307" name="Imagen 5" descr="NewLogo_EBMT_RGB.png"/>
          <p:cNvPicPr/>
          <p:nvPr/>
        </p:nvPicPr>
        <p:blipFill>
          <a:blip r:embed="rId3"/>
          <a:stretch/>
        </p:blipFill>
        <p:spPr>
          <a:xfrm>
            <a:off x="73080" y="85680"/>
            <a:ext cx="1522440" cy="765360"/>
          </a:xfrm>
          <a:prstGeom prst="rect">
            <a:avLst/>
          </a:prstGeom>
          <a:ln w="0">
            <a:noFill/>
          </a:ln>
        </p:spPr>
      </p:pic>
      <p:sp>
        <p:nvSpPr>
          <p:cNvPr id="308" name="Rectangle 2"/>
          <p:cNvSpPr/>
          <p:nvPr/>
        </p:nvSpPr>
        <p:spPr>
          <a:xfrm>
            <a:off x="0" y="6570720"/>
            <a:ext cx="9144000" cy="287280"/>
          </a:xfrm>
          <a:prstGeom prst="rect">
            <a:avLst/>
          </a:prstGeom>
          <a:solidFill>
            <a:srgbClr val="213d8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5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 algn="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9" name="Espace réservé du numéro de diapositive 11"/>
          <p:cNvSpPr/>
          <p:nvPr/>
        </p:nvSpPr>
        <p:spPr>
          <a:xfrm>
            <a:off x="8345520" y="6570720"/>
            <a:ext cx="59040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484632-9FFC-4487-B6EF-51C385B8CC0A}" type="slidenum">
              <a:rPr b="1" lang="en-GB" sz="1000" spc="-1" strike="noStrike">
                <a:solidFill>
                  <a:srgbClr val="ffffff"/>
                </a:solidFill>
                <a:latin typeface="Arial"/>
                <a:ea typeface="Geneva"/>
              </a:rPr>
              <a:t>&lt;number&gt;</a:t>
            </a:fld>
            <a:endParaRPr b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60ad"/>
                </a:solidFill>
                <a:latin typeface="Arial"/>
              </a:rPr>
              <a:t>Click to edit the title text format</a:t>
            </a:r>
            <a:endParaRPr b="0" lang="en-US" sz="3400" spc="-1" strike="noStrike">
              <a:solidFill>
                <a:srgbClr val="0060ad"/>
              </a:solidFill>
              <a:latin typeface="Arial"/>
            </a:endParaRPr>
          </a:p>
        </p:txBody>
      </p:sp>
      <p:sp>
        <p:nvSpPr>
          <p:cNvPr id="31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4"/>
    <p:sldLayoutId id="2147483754" r:id="rId5"/>
    <p:sldLayoutId id="2147483755" r:id="rId6"/>
    <p:sldLayoutId id="2147483756" r:id="rId7"/>
    <p:sldLayoutId id="2147483757" r:id="rId8"/>
    <p:sldLayoutId id="2147483758" r:id="rId9"/>
    <p:sldLayoutId id="2147483759" r:id="rId10"/>
    <p:sldLayoutId id="2147483760" r:id="rId11"/>
    <p:sldLayoutId id="2147483761" r:id="rId12"/>
    <p:sldLayoutId id="2147483762" r:id="rId13"/>
    <p:sldLayoutId id="2147483763" r:id="rId14"/>
    <p:sldLayoutId id="2147483764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97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PlaceHolder 1"/>
          <p:cNvSpPr>
            <a:spLocks noGrp="1"/>
          </p:cNvSpPr>
          <p:nvPr>
            <p:ph/>
          </p:nvPr>
        </p:nvSpPr>
        <p:spPr>
          <a:xfrm>
            <a:off x="471600" y="6570720"/>
            <a:ext cx="7937280" cy="28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1200" spc="-1" strike="noStrike">
              <a:solidFill>
                <a:srgbClr val="ffffff"/>
              </a:solidFill>
              <a:latin typeface="Arial"/>
              <a:ea typeface="Arial"/>
            </a:endParaRPr>
          </a:p>
        </p:txBody>
      </p:sp>
      <p:sp>
        <p:nvSpPr>
          <p:cNvPr id="356" name="Line 3"/>
          <p:cNvSpPr/>
          <p:nvPr/>
        </p:nvSpPr>
        <p:spPr>
          <a:xfrm>
            <a:off x="1295280" y="1981080"/>
            <a:ext cx="56880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7" name="Text Box 7"/>
          <p:cNvSpPr/>
          <p:nvPr/>
        </p:nvSpPr>
        <p:spPr>
          <a:xfrm>
            <a:off x="152280" y="1371600"/>
            <a:ext cx="48769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Days 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after HSCT           0        ≥ +60 </a:t>
            </a: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	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8" name="Rectangle 10"/>
          <p:cNvSpPr/>
          <p:nvPr/>
        </p:nvSpPr>
        <p:spPr>
          <a:xfrm>
            <a:off x="1295280" y="2692440"/>
            <a:ext cx="571680" cy="431640"/>
          </a:xfrm>
          <a:prstGeom prst="rect">
            <a:avLst/>
          </a:prstGeom>
          <a:solidFill>
            <a:srgbClr val="b9cde5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Cond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9" name="Rectangle 15"/>
          <p:cNvSpPr/>
          <p:nvPr/>
        </p:nvSpPr>
        <p:spPr>
          <a:xfrm>
            <a:off x="1963800" y="2157480"/>
            <a:ext cx="2836800" cy="433440"/>
          </a:xfrm>
          <a:prstGeom prst="rect">
            <a:avLst/>
          </a:prstGeom>
          <a:gradFill rotWithShape="0">
            <a:gsLst>
              <a:gs pos="0">
                <a:srgbClr val="77933c"/>
              </a:gs>
              <a:gs pos="100000">
                <a:srgbClr val="ffffff"/>
              </a:gs>
            </a:gsLst>
            <a:lin ang="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Standard immunosuppression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0" name="Rectangle 20"/>
          <p:cNvSpPr/>
          <p:nvPr/>
        </p:nvSpPr>
        <p:spPr>
          <a:xfrm>
            <a:off x="2484360" y="2666880"/>
            <a:ext cx="4525920" cy="505080"/>
          </a:xfrm>
          <a:prstGeom prst="rect">
            <a:avLst/>
          </a:prstGeom>
          <a:solidFill>
            <a:srgbClr val="fac09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Panobinostat TIW, every week (max. 1 year)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1" name="Rectangle 28"/>
          <p:cNvSpPr/>
          <p:nvPr/>
        </p:nvSpPr>
        <p:spPr>
          <a:xfrm>
            <a:off x="5646600" y="2370240"/>
            <a:ext cx="185760" cy="33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2" name="Text Box 31"/>
          <p:cNvSpPr/>
          <p:nvPr/>
        </p:nvSpPr>
        <p:spPr>
          <a:xfrm>
            <a:off x="1545120" y="914400"/>
            <a:ext cx="73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HSCT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cxnSp>
        <p:nvCxnSpPr>
          <p:cNvPr id="363" name="Gerade Verbindung mit Pfeil 18"/>
          <p:cNvCxnSpPr/>
          <p:nvPr/>
        </p:nvCxnSpPr>
        <p:spPr>
          <a:xfrm flipH="1">
            <a:off x="1904760" y="1294920"/>
            <a:ext cx="2160" cy="3056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364" name="Text Box 7" descr=""/>
          <p:cNvPicPr/>
          <p:nvPr/>
        </p:nvPicPr>
        <p:blipFill>
          <a:blip r:embed="rId1"/>
          <a:stretch/>
        </p:blipFill>
        <p:spPr>
          <a:xfrm>
            <a:off x="7095960" y="2571840"/>
            <a:ext cx="1938600" cy="3359160"/>
          </a:xfrm>
          <a:prstGeom prst="rect">
            <a:avLst/>
          </a:prstGeom>
          <a:ln w="0">
            <a:noFill/>
          </a:ln>
        </p:spPr>
      </p:pic>
      <p:sp>
        <p:nvSpPr>
          <p:cNvPr id="365" name="Rectangle 20"/>
          <p:cNvSpPr/>
          <p:nvPr/>
        </p:nvSpPr>
        <p:spPr>
          <a:xfrm>
            <a:off x="2484360" y="3809880"/>
            <a:ext cx="4525920" cy="505080"/>
          </a:xfrm>
          <a:prstGeom prst="rect">
            <a:avLst/>
          </a:prstGeom>
          <a:solidFill>
            <a:srgbClr val="fac09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Panobinostat TIW, every 2nd week (max. 1 year)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cxnSp>
        <p:nvCxnSpPr>
          <p:cNvPr id="366" name="Gerade Verbindung mit Pfeil 22"/>
          <p:cNvCxnSpPr/>
          <p:nvPr/>
        </p:nvCxnSpPr>
        <p:spPr>
          <a:xfrm flipH="1">
            <a:off x="4723560" y="3352320"/>
            <a:ext cx="2520" cy="3056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67" name="Rectangle 20"/>
          <p:cNvSpPr/>
          <p:nvPr/>
        </p:nvSpPr>
        <p:spPr>
          <a:xfrm>
            <a:off x="2484360" y="4981680"/>
            <a:ext cx="1935360" cy="885600"/>
          </a:xfrm>
          <a:prstGeom prst="rect">
            <a:avLst/>
          </a:prstGeom>
          <a:solidFill>
            <a:srgbClr val="fac09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Panobinostat TIW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every week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(max. 1 year)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8" name="Rectangle 20"/>
          <p:cNvSpPr/>
          <p:nvPr/>
        </p:nvSpPr>
        <p:spPr>
          <a:xfrm>
            <a:off x="5029200" y="4981680"/>
            <a:ext cx="1981080" cy="885600"/>
          </a:xfrm>
          <a:prstGeom prst="rect">
            <a:avLst/>
          </a:prstGeom>
          <a:solidFill>
            <a:srgbClr val="fac09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Panobinostat TIW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every 2nd week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ffffff"/>
                </a:solidFill>
                <a:latin typeface="Arial"/>
                <a:ea typeface="Geneva"/>
              </a:rPr>
              <a:t>(max. 1 year)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cxnSp>
        <p:nvCxnSpPr>
          <p:cNvPr id="369" name="Gerade Verbindung mit Pfeil 25"/>
          <p:cNvCxnSpPr/>
          <p:nvPr/>
        </p:nvCxnSpPr>
        <p:spPr>
          <a:xfrm flipH="1">
            <a:off x="4723560" y="4419720"/>
            <a:ext cx="2520" cy="305280"/>
          </a:xfrm>
          <a:prstGeom prst="straightConnector1">
            <a:avLst/>
          </a:prstGeom>
          <a:ln w="38160">
            <a:solidFill>
              <a:srgbClr val="000000"/>
            </a:solidFill>
            <a:miter/>
          </a:ln>
        </p:spPr>
      </p:cxnSp>
      <p:cxnSp>
        <p:nvCxnSpPr>
          <p:cNvPr id="370" name="Gerade Verbindung mit Pfeil 26"/>
          <p:cNvCxnSpPr/>
          <p:nvPr/>
        </p:nvCxnSpPr>
        <p:spPr>
          <a:xfrm flipH="1">
            <a:off x="4419360" y="4724280"/>
            <a:ext cx="305280" cy="1533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1" name="Gerade Verbindung mit Pfeil 29"/>
          <p:cNvCxnSpPr/>
          <p:nvPr/>
        </p:nvCxnSpPr>
        <p:spPr>
          <a:xfrm>
            <a:off x="4723920" y="4724280"/>
            <a:ext cx="305640" cy="1533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72" name="Textfeld 31"/>
          <p:cNvSpPr/>
          <p:nvPr/>
        </p:nvSpPr>
        <p:spPr>
          <a:xfrm>
            <a:off x="4803480" y="43434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ffffff"/>
                </a:solidFill>
                <a:latin typeface="Arial"/>
                <a:ea typeface="Geneva"/>
              </a:rPr>
              <a:t>R</a:t>
            </a: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3" name="Textfeld 1"/>
          <p:cNvSpPr/>
          <p:nvPr/>
        </p:nvSpPr>
        <p:spPr>
          <a:xfrm>
            <a:off x="185760" y="260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ffffff"/>
                </a:solidFill>
                <a:latin typeface="Arial"/>
                <a:ea typeface="Geneva"/>
              </a:rPr>
              <a:t>Figure S1</a:t>
            </a: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09T11:54:16Z</dcterms:created>
  <dc:creator>psmitrou</dc:creator>
  <dc:description/>
  <dc:language>en-US</dc:language>
  <cp:lastModifiedBy>ravikumar.n</cp:lastModifiedBy>
  <cp:lastPrinted>2016-10-30T21:04:44Z</cp:lastPrinted>
  <dcterms:modified xsi:type="dcterms:W3CDTF">2017-08-28T16:30:50Z</dcterms:modified>
  <cp:revision>1266</cp:revision>
  <dc:subject/>
  <dc:title>Folie 1</dc:title>
</cp:coreProperties>
</file>